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06" autoAdjust="0"/>
    <p:restoredTop sz="94660"/>
  </p:normalViewPr>
  <p:slideViewPr>
    <p:cSldViewPr snapToGrid="0" showGuides="1">
      <p:cViewPr varScale="1">
        <p:scale>
          <a:sx n="110" d="100"/>
          <a:sy n="110" d="100"/>
        </p:scale>
        <p:origin x="492" y="114"/>
      </p:cViewPr>
      <p:guideLst>
        <p:guide orient="horz" pos="2160"/>
        <p:guide pos="3840"/>
      </p:guideLst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70D8-F7A5-4A6D-80E1-7D6782A02A46}" type="datetimeFigureOut">
              <a:rPr lang="en-US" smtClean="0"/>
              <a:t>7/2/2024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C9215-081A-4581-A0C9-14D5E063600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13144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70D8-F7A5-4A6D-80E1-7D6782A02A46}" type="datetimeFigureOut">
              <a:rPr lang="en-US" smtClean="0"/>
              <a:t>7/2/2024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C9215-081A-4581-A0C9-14D5E063600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574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70D8-F7A5-4A6D-80E1-7D6782A02A46}" type="datetimeFigureOut">
              <a:rPr lang="en-US" smtClean="0"/>
              <a:t>7/2/2024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C9215-081A-4581-A0C9-14D5E063600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58319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70D8-F7A5-4A6D-80E1-7D6782A02A46}" type="datetimeFigureOut">
              <a:rPr lang="en-US" smtClean="0"/>
              <a:t>7/2/2024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C9215-081A-4581-A0C9-14D5E063600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94355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70D8-F7A5-4A6D-80E1-7D6782A02A46}" type="datetimeFigureOut">
              <a:rPr lang="en-US" smtClean="0"/>
              <a:t>7/2/2024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C9215-081A-4581-A0C9-14D5E063600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71605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70D8-F7A5-4A6D-80E1-7D6782A02A46}" type="datetimeFigureOut">
              <a:rPr lang="en-US" smtClean="0"/>
              <a:t>7/2/2024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C9215-081A-4581-A0C9-14D5E063600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72658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70D8-F7A5-4A6D-80E1-7D6782A02A46}" type="datetimeFigureOut">
              <a:rPr lang="en-US" smtClean="0"/>
              <a:t>7/2/2024</a:t>
            </a:fld>
            <a:endParaRPr lang="en-US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C9215-081A-4581-A0C9-14D5E063600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86868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70D8-F7A5-4A6D-80E1-7D6782A02A46}" type="datetimeFigureOut">
              <a:rPr lang="en-US" smtClean="0"/>
              <a:t>7/2/2024</a:t>
            </a:fld>
            <a:endParaRPr lang="en-US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C9215-081A-4581-A0C9-14D5E063600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89404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70D8-F7A5-4A6D-80E1-7D6782A02A46}" type="datetimeFigureOut">
              <a:rPr lang="en-US" smtClean="0"/>
              <a:t>7/2/2024</a:t>
            </a:fld>
            <a:endParaRPr lang="en-US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C9215-081A-4581-A0C9-14D5E063600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28070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70D8-F7A5-4A6D-80E1-7D6782A02A46}" type="datetimeFigureOut">
              <a:rPr lang="en-US" smtClean="0"/>
              <a:t>7/2/2024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C9215-081A-4581-A0C9-14D5E063600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81481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70D8-F7A5-4A6D-80E1-7D6782A02A46}" type="datetimeFigureOut">
              <a:rPr lang="en-US" smtClean="0"/>
              <a:t>7/2/2024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C9215-081A-4581-A0C9-14D5E063600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7049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9470D8-F7A5-4A6D-80E1-7D6782A02A46}" type="datetimeFigureOut">
              <a:rPr lang="en-US" smtClean="0"/>
              <a:t>7/2/2024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EC9215-081A-4581-A0C9-14D5E063600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78553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asellaDiTesto 4">
            <a:extLst>
              <a:ext uri="{FF2B5EF4-FFF2-40B4-BE49-F238E27FC236}">
                <a16:creationId xmlns:a16="http://schemas.microsoft.com/office/drawing/2014/main" id="{9FD5D425-42F0-4B1C-A56D-C9FE63A7216F}"/>
              </a:ext>
            </a:extLst>
          </p:cNvPr>
          <p:cNvSpPr txBox="1"/>
          <p:nvPr/>
        </p:nvSpPr>
        <p:spPr>
          <a:xfrm>
            <a:off x="732711" y="96892"/>
            <a:ext cx="1002833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>
                <a:latin typeface="Times New Roman" panose="02020603050405020304" pitchFamily="18" charset="0"/>
                <a:cs typeface="Times New Roman" panose="02020603050405020304" pitchFamily="18" charset="0"/>
              </a:rPr>
              <a:t>Figure S4: 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relation between taxa at family level. Pearson’s r are reported and pie graph’ size represents the relative abundance of each taxon. Boxplots represent the relative abundance of the three taxa in each type of sample.</a:t>
            </a:r>
          </a:p>
        </p:txBody>
      </p:sp>
      <p:pic>
        <p:nvPicPr>
          <p:cNvPr id="6" name="Immagine 5">
            <a:extLst>
              <a:ext uri="{FF2B5EF4-FFF2-40B4-BE49-F238E27FC236}">
                <a16:creationId xmlns:a16="http://schemas.microsoft.com/office/drawing/2014/main" id="{C8E6072A-BFFF-4FCC-BFC9-7C0163FA1DA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383" y="1057645"/>
            <a:ext cx="6044045" cy="5178136"/>
          </a:xfrm>
          <a:prstGeom prst="rect">
            <a:avLst/>
          </a:prstGeom>
        </p:spPr>
      </p:pic>
      <p:pic>
        <p:nvPicPr>
          <p:cNvPr id="3" name="Immagine 2">
            <a:extLst>
              <a:ext uri="{FF2B5EF4-FFF2-40B4-BE49-F238E27FC236}">
                <a16:creationId xmlns:a16="http://schemas.microsoft.com/office/drawing/2014/main" id="{AE36BC83-04FB-485C-B6FD-77E092C4C76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04574" y="3798883"/>
            <a:ext cx="2755165" cy="2361570"/>
          </a:xfrm>
          <a:prstGeom prst="rect">
            <a:avLst/>
          </a:prstGeom>
        </p:spPr>
      </p:pic>
      <p:pic>
        <p:nvPicPr>
          <p:cNvPr id="8" name="Immagine 7">
            <a:extLst>
              <a:ext uri="{FF2B5EF4-FFF2-40B4-BE49-F238E27FC236}">
                <a16:creationId xmlns:a16="http://schemas.microsoft.com/office/drawing/2014/main" id="{9C6DB086-5AF1-46DF-AFB2-AD0C0CFB153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04574" y="941929"/>
            <a:ext cx="2755165" cy="2361570"/>
          </a:xfrm>
          <a:prstGeom prst="rect">
            <a:avLst/>
          </a:prstGeom>
        </p:spPr>
      </p:pic>
      <p:pic>
        <p:nvPicPr>
          <p:cNvPr id="10" name="Immagine 9">
            <a:extLst>
              <a:ext uri="{FF2B5EF4-FFF2-40B4-BE49-F238E27FC236}">
                <a16:creationId xmlns:a16="http://schemas.microsoft.com/office/drawing/2014/main" id="{B2FDB913-79BA-4D84-B45F-198772207D56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016915" y="941929"/>
            <a:ext cx="2755165" cy="236157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7342062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3</TotalTime>
  <Words>42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i Office</vt:lpstr>
      <vt:lpstr>Presentazione standard di PowerPoint</vt:lpstr>
    </vt:vector>
  </TitlesOfParts>
  <Company>Università degli Studi di Padov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Laconi Andrea</dc:creator>
  <cp:lastModifiedBy>Andrea Laconi</cp:lastModifiedBy>
  <cp:revision>17</cp:revision>
  <dcterms:created xsi:type="dcterms:W3CDTF">2022-03-15T12:01:40Z</dcterms:created>
  <dcterms:modified xsi:type="dcterms:W3CDTF">2024-07-02T09:39:44Z</dcterms:modified>
</cp:coreProperties>
</file>